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handoutMasters/handoutMaster1.xml" ContentType="application/vnd.openxmlformats-officedocument.presentationml.handoutMaster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handoutMasterIdLst>
    <p:handoutMasterId r:id="rId4"/>
  </p:handoutMasterIdLst>
  <p:sldIdLst>
    <p:sldId id="257" r:id="rId2"/>
  </p:sldIdLst>
  <p:sldSz cx="12960350" cy="21959888"/>
  <p:notesSz cx="6889750" cy="1002188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068" autoAdjust="0"/>
    <p:restoredTop sz="94660"/>
  </p:normalViewPr>
  <p:slideViewPr>
    <p:cSldViewPr snapToGrid="0">
      <p:cViewPr>
        <p:scale>
          <a:sx n="48" d="100"/>
          <a:sy n="48" d="100"/>
        </p:scale>
        <p:origin x="-1542" y="-78"/>
      </p:cViewPr>
      <p:guideLst>
        <p:guide orient="horz" pos="6916"/>
        <p:guide pos="408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5558" cy="502835"/>
          </a:xfrm>
          <a:prstGeom prst="rect">
            <a:avLst/>
          </a:prstGeom>
        </p:spPr>
        <p:txBody>
          <a:bodyPr vert="horz" lIns="96634" tIns="48317" rIns="96634" bIns="48317" rtlCol="0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3902597" y="0"/>
            <a:ext cx="2985558" cy="502835"/>
          </a:xfrm>
          <a:prstGeom prst="rect">
            <a:avLst/>
          </a:prstGeom>
        </p:spPr>
        <p:txBody>
          <a:bodyPr vert="horz" lIns="96634" tIns="48317" rIns="96634" bIns="48317" rtlCol="0"/>
          <a:lstStyle>
            <a:lvl1pPr algn="r">
              <a:defRPr sz="1300"/>
            </a:lvl1pPr>
          </a:lstStyle>
          <a:p>
            <a:fld id="{0865300D-C0DB-4A38-BD44-A77EA31991B3}" type="datetimeFigureOut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0" y="9519055"/>
            <a:ext cx="2985558" cy="502834"/>
          </a:xfrm>
          <a:prstGeom prst="rect">
            <a:avLst/>
          </a:prstGeom>
        </p:spPr>
        <p:txBody>
          <a:bodyPr vert="horz" lIns="96634" tIns="48317" rIns="96634" bIns="48317" rtlCol="0" anchor="b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3902597" y="9519055"/>
            <a:ext cx="2985558" cy="502834"/>
          </a:xfrm>
          <a:prstGeom prst="rect">
            <a:avLst/>
          </a:prstGeom>
        </p:spPr>
        <p:txBody>
          <a:bodyPr vert="horz" lIns="96634" tIns="48317" rIns="96634" bIns="48317" rtlCol="0" anchor="b"/>
          <a:lstStyle>
            <a:lvl1pPr algn="r">
              <a:defRPr sz="1300"/>
            </a:lvl1pPr>
          </a:lstStyle>
          <a:p>
            <a:fld id="{674C055D-3DDC-4A69-8032-9333AC9DD4D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859915682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5558" cy="502835"/>
          </a:xfrm>
          <a:prstGeom prst="rect">
            <a:avLst/>
          </a:prstGeom>
        </p:spPr>
        <p:txBody>
          <a:bodyPr vert="horz" lIns="96634" tIns="48317" rIns="96634" bIns="48317" rtlCol="0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902597" y="0"/>
            <a:ext cx="2985558" cy="502835"/>
          </a:xfrm>
          <a:prstGeom prst="rect">
            <a:avLst/>
          </a:prstGeom>
        </p:spPr>
        <p:txBody>
          <a:bodyPr vert="horz" lIns="96634" tIns="48317" rIns="96634" bIns="48317" rtlCol="0"/>
          <a:lstStyle>
            <a:lvl1pPr algn="r">
              <a:defRPr sz="1300"/>
            </a:lvl1pPr>
          </a:lstStyle>
          <a:p>
            <a:fld id="{8CBEB62A-5263-4422-9935-2F8A43E720BE}" type="datetimeFigureOut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447925" y="1252538"/>
            <a:ext cx="1993900" cy="338296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34" tIns="48317" rIns="96634" bIns="48317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8975" y="4823034"/>
            <a:ext cx="5511800" cy="3946118"/>
          </a:xfrm>
          <a:prstGeom prst="rect">
            <a:avLst/>
          </a:prstGeom>
        </p:spPr>
        <p:txBody>
          <a:bodyPr vert="horz" lIns="96634" tIns="48317" rIns="96634" bIns="48317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519055"/>
            <a:ext cx="2985558" cy="502834"/>
          </a:xfrm>
          <a:prstGeom prst="rect">
            <a:avLst/>
          </a:prstGeom>
        </p:spPr>
        <p:txBody>
          <a:bodyPr vert="horz" lIns="96634" tIns="48317" rIns="96634" bIns="48317" rtlCol="0" anchor="b"/>
          <a:lstStyle>
            <a:lvl1pPr algn="l">
              <a:defRPr sz="13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902597" y="9519055"/>
            <a:ext cx="2985558" cy="502834"/>
          </a:xfrm>
          <a:prstGeom prst="rect">
            <a:avLst/>
          </a:prstGeom>
        </p:spPr>
        <p:txBody>
          <a:bodyPr vert="horz" lIns="96634" tIns="48317" rIns="96634" bIns="48317" rtlCol="0" anchor="b"/>
          <a:lstStyle>
            <a:lvl1pPr algn="r">
              <a:defRPr sz="1300"/>
            </a:lvl1pPr>
          </a:lstStyle>
          <a:p>
            <a:fld id="{D3554FBB-5347-4C5F-BB9D-09F70482850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920570996"/>
      </p:ext>
    </p:extLst>
  </p:cSld>
  <p:clrMap bg1="lt1" tx1="dk1" bg2="lt2" tx2="dk2" accent1="accent1" accent2="accent2" accent3="accent3" accent4="accent4" accent5="accent5" accent6="accent6" hlink="hlink" folHlink="folHlink"/>
  <p:hf sldNum="0" hdr="0" ftr="0" dt="0"/>
  <p:notesStyle>
    <a:lvl1pPr marL="0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1pPr>
    <a:lvl2pPr marL="837965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2pPr>
    <a:lvl3pPr marL="1675930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3pPr>
    <a:lvl4pPr marL="2513895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4pPr>
    <a:lvl5pPr marL="3351860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5pPr>
    <a:lvl6pPr marL="4189826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6pPr>
    <a:lvl7pPr marL="5027791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7pPr>
    <a:lvl8pPr marL="5865756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8pPr>
    <a:lvl9pPr marL="6703721" algn="l" defTabSz="1675930" rtl="0" eaLnBrk="1" latinLnBrk="1" hangingPunct="1">
      <a:defRPr sz="2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72026" y="3593900"/>
            <a:ext cx="11016298" cy="7645294"/>
          </a:xfrm>
        </p:spPr>
        <p:txBody>
          <a:bodyPr anchor="b"/>
          <a:lstStyle>
            <a:lvl1pPr algn="ctr">
              <a:defRPr sz="8504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20045" y="11534026"/>
            <a:ext cx="9720263" cy="5301888"/>
          </a:xfrm>
        </p:spPr>
        <p:txBody>
          <a:bodyPr/>
          <a:lstStyle>
            <a:lvl1pPr marL="0" indent="0" algn="ctr">
              <a:buNone/>
              <a:defRPr sz="3402"/>
            </a:lvl1pPr>
            <a:lvl2pPr marL="648004" indent="0" algn="ctr">
              <a:buNone/>
              <a:defRPr sz="2835"/>
            </a:lvl2pPr>
            <a:lvl3pPr marL="1296008" indent="0" algn="ctr">
              <a:buNone/>
              <a:defRPr sz="2551"/>
            </a:lvl3pPr>
            <a:lvl4pPr marL="1944013" indent="0" algn="ctr">
              <a:buNone/>
              <a:defRPr sz="2268"/>
            </a:lvl4pPr>
            <a:lvl5pPr marL="2592017" indent="0" algn="ctr">
              <a:buNone/>
              <a:defRPr sz="2268"/>
            </a:lvl5pPr>
            <a:lvl6pPr marL="3240020" indent="0" algn="ctr">
              <a:buNone/>
              <a:defRPr sz="2268"/>
            </a:lvl6pPr>
            <a:lvl7pPr marL="3888025" indent="0" algn="ctr">
              <a:buNone/>
              <a:defRPr sz="2268"/>
            </a:lvl7pPr>
            <a:lvl8pPr marL="4536030" indent="0" algn="ctr">
              <a:buNone/>
              <a:defRPr sz="2268"/>
            </a:lvl8pPr>
            <a:lvl9pPr marL="5184033" indent="0" algn="ctr">
              <a:buNone/>
              <a:defRPr sz="2268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933E5F-05D8-4883-BBA5-F544EA65A67D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09468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378F2E-E25A-4875-A211-19CDE50E7B66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8634589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274753" y="1169161"/>
            <a:ext cx="2794575" cy="18609990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91025" y="1169161"/>
            <a:ext cx="8221722" cy="18609990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923612-7092-43E6-87EE-5F3D47EAF4DF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7751473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D0705D-CDE0-4A8B-BD00-0C51EB3C5965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7144320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84275" y="5474729"/>
            <a:ext cx="11178302" cy="9134702"/>
          </a:xfrm>
        </p:spPr>
        <p:txBody>
          <a:bodyPr anchor="b"/>
          <a:lstStyle>
            <a:lvl1pPr>
              <a:defRPr sz="8504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84275" y="14695848"/>
            <a:ext cx="11178302" cy="4803724"/>
          </a:xfrm>
        </p:spPr>
        <p:txBody>
          <a:bodyPr/>
          <a:lstStyle>
            <a:lvl1pPr marL="0" indent="0">
              <a:buNone/>
              <a:defRPr sz="3402">
                <a:solidFill>
                  <a:schemeClr val="tx1"/>
                </a:solidFill>
              </a:defRPr>
            </a:lvl1pPr>
            <a:lvl2pPr marL="648004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2pPr>
            <a:lvl3pPr marL="1296008" indent="0">
              <a:buNone/>
              <a:defRPr sz="2551">
                <a:solidFill>
                  <a:schemeClr val="tx1">
                    <a:tint val="75000"/>
                  </a:schemeClr>
                </a:solidFill>
              </a:defRPr>
            </a:lvl3pPr>
            <a:lvl4pPr marL="1944013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4pPr>
            <a:lvl5pPr marL="2592017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5pPr>
            <a:lvl6pPr marL="3240020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6pPr>
            <a:lvl7pPr marL="3888025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7pPr>
            <a:lvl8pPr marL="4536030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8pPr>
            <a:lvl9pPr marL="5184033" indent="0">
              <a:buNone/>
              <a:defRPr sz="2268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04F3DD-5303-44B3-94EB-3881814DB7A2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41112720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91024" y="5845805"/>
            <a:ext cx="5508149" cy="13933347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561179" y="5845805"/>
            <a:ext cx="5508149" cy="13933347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F68C83-F889-49C6-8258-A889429BD78F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4724813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92712" y="1169166"/>
            <a:ext cx="11178302" cy="4244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92715" y="5383224"/>
            <a:ext cx="5482835" cy="2638235"/>
          </a:xfrm>
        </p:spPr>
        <p:txBody>
          <a:bodyPr anchor="b"/>
          <a:lstStyle>
            <a:lvl1pPr marL="0" indent="0">
              <a:buNone/>
              <a:defRPr sz="3402" b="1"/>
            </a:lvl1pPr>
            <a:lvl2pPr marL="648004" indent="0">
              <a:buNone/>
              <a:defRPr sz="2835" b="1"/>
            </a:lvl2pPr>
            <a:lvl3pPr marL="1296008" indent="0">
              <a:buNone/>
              <a:defRPr sz="2551" b="1"/>
            </a:lvl3pPr>
            <a:lvl4pPr marL="1944013" indent="0">
              <a:buNone/>
              <a:defRPr sz="2268" b="1"/>
            </a:lvl4pPr>
            <a:lvl5pPr marL="2592017" indent="0">
              <a:buNone/>
              <a:defRPr sz="2268" b="1"/>
            </a:lvl5pPr>
            <a:lvl6pPr marL="3240020" indent="0">
              <a:buNone/>
              <a:defRPr sz="2268" b="1"/>
            </a:lvl6pPr>
            <a:lvl7pPr marL="3888025" indent="0">
              <a:buNone/>
              <a:defRPr sz="2268" b="1"/>
            </a:lvl7pPr>
            <a:lvl8pPr marL="4536030" indent="0">
              <a:buNone/>
              <a:defRPr sz="2268" b="1"/>
            </a:lvl8pPr>
            <a:lvl9pPr marL="5184033" indent="0">
              <a:buNone/>
              <a:defRPr sz="2268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92715" y="8021460"/>
            <a:ext cx="5482835" cy="1179835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561180" y="5383224"/>
            <a:ext cx="5509837" cy="2638235"/>
          </a:xfrm>
        </p:spPr>
        <p:txBody>
          <a:bodyPr anchor="b"/>
          <a:lstStyle>
            <a:lvl1pPr marL="0" indent="0">
              <a:buNone/>
              <a:defRPr sz="3402" b="1"/>
            </a:lvl1pPr>
            <a:lvl2pPr marL="648004" indent="0">
              <a:buNone/>
              <a:defRPr sz="2835" b="1"/>
            </a:lvl2pPr>
            <a:lvl3pPr marL="1296008" indent="0">
              <a:buNone/>
              <a:defRPr sz="2551" b="1"/>
            </a:lvl3pPr>
            <a:lvl4pPr marL="1944013" indent="0">
              <a:buNone/>
              <a:defRPr sz="2268" b="1"/>
            </a:lvl4pPr>
            <a:lvl5pPr marL="2592017" indent="0">
              <a:buNone/>
              <a:defRPr sz="2268" b="1"/>
            </a:lvl5pPr>
            <a:lvl6pPr marL="3240020" indent="0">
              <a:buNone/>
              <a:defRPr sz="2268" b="1"/>
            </a:lvl6pPr>
            <a:lvl7pPr marL="3888025" indent="0">
              <a:buNone/>
              <a:defRPr sz="2268" b="1"/>
            </a:lvl7pPr>
            <a:lvl8pPr marL="4536030" indent="0">
              <a:buNone/>
              <a:defRPr sz="2268" b="1"/>
            </a:lvl8pPr>
            <a:lvl9pPr marL="5184033" indent="0">
              <a:buNone/>
              <a:defRPr sz="2268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561180" y="8021460"/>
            <a:ext cx="5509837" cy="1179835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F85AAA-86E6-4820-B832-9D5BB2BD7504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2441098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D3C208-5E4C-41D1-9C78-730AEC10AC88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42151795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B92E73-36E3-4BA5-A847-F77E213AA44F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5142106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92712" y="1463993"/>
            <a:ext cx="4180050" cy="5123974"/>
          </a:xfrm>
        </p:spPr>
        <p:txBody>
          <a:bodyPr anchor="b"/>
          <a:lstStyle>
            <a:lvl1pPr>
              <a:defRPr sz="4536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509839" y="3161822"/>
            <a:ext cx="6561177" cy="15605754"/>
          </a:xfrm>
        </p:spPr>
        <p:txBody>
          <a:bodyPr/>
          <a:lstStyle>
            <a:lvl1pPr>
              <a:defRPr sz="4536"/>
            </a:lvl1pPr>
            <a:lvl2pPr>
              <a:defRPr sz="3968"/>
            </a:lvl2pPr>
            <a:lvl3pPr>
              <a:defRPr sz="3402"/>
            </a:lvl3pPr>
            <a:lvl4pPr>
              <a:defRPr sz="2835"/>
            </a:lvl4pPr>
            <a:lvl5pPr>
              <a:defRPr sz="2835"/>
            </a:lvl5pPr>
            <a:lvl6pPr>
              <a:defRPr sz="2835"/>
            </a:lvl6pPr>
            <a:lvl7pPr>
              <a:defRPr sz="2835"/>
            </a:lvl7pPr>
            <a:lvl8pPr>
              <a:defRPr sz="2835"/>
            </a:lvl8pPr>
            <a:lvl9pPr>
              <a:defRPr sz="2835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92712" y="6587967"/>
            <a:ext cx="4180050" cy="12205023"/>
          </a:xfrm>
        </p:spPr>
        <p:txBody>
          <a:bodyPr/>
          <a:lstStyle>
            <a:lvl1pPr marL="0" indent="0">
              <a:buNone/>
              <a:defRPr sz="2268"/>
            </a:lvl1pPr>
            <a:lvl2pPr marL="648004" indent="0">
              <a:buNone/>
              <a:defRPr sz="1984"/>
            </a:lvl2pPr>
            <a:lvl3pPr marL="1296008" indent="0">
              <a:buNone/>
              <a:defRPr sz="1701"/>
            </a:lvl3pPr>
            <a:lvl4pPr marL="1944013" indent="0">
              <a:buNone/>
              <a:defRPr sz="1418"/>
            </a:lvl4pPr>
            <a:lvl5pPr marL="2592017" indent="0">
              <a:buNone/>
              <a:defRPr sz="1418"/>
            </a:lvl5pPr>
            <a:lvl6pPr marL="3240020" indent="0">
              <a:buNone/>
              <a:defRPr sz="1418"/>
            </a:lvl6pPr>
            <a:lvl7pPr marL="3888025" indent="0">
              <a:buNone/>
              <a:defRPr sz="1418"/>
            </a:lvl7pPr>
            <a:lvl8pPr marL="4536030" indent="0">
              <a:buNone/>
              <a:defRPr sz="1418"/>
            </a:lvl8pPr>
            <a:lvl9pPr marL="5184033" indent="0">
              <a:buNone/>
              <a:defRPr sz="1418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7ED3DE-4B30-48B5-95BB-DF6A3298C28C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1910707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92712" y="1463993"/>
            <a:ext cx="4180050" cy="5123974"/>
          </a:xfrm>
        </p:spPr>
        <p:txBody>
          <a:bodyPr anchor="b"/>
          <a:lstStyle>
            <a:lvl1pPr>
              <a:defRPr sz="4536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509839" y="3161822"/>
            <a:ext cx="6561177" cy="15605754"/>
          </a:xfrm>
        </p:spPr>
        <p:txBody>
          <a:bodyPr anchor="t"/>
          <a:lstStyle>
            <a:lvl1pPr marL="0" indent="0">
              <a:buNone/>
              <a:defRPr sz="4536"/>
            </a:lvl1pPr>
            <a:lvl2pPr marL="648004" indent="0">
              <a:buNone/>
              <a:defRPr sz="3968"/>
            </a:lvl2pPr>
            <a:lvl3pPr marL="1296008" indent="0">
              <a:buNone/>
              <a:defRPr sz="3402"/>
            </a:lvl3pPr>
            <a:lvl4pPr marL="1944013" indent="0">
              <a:buNone/>
              <a:defRPr sz="2835"/>
            </a:lvl4pPr>
            <a:lvl5pPr marL="2592017" indent="0">
              <a:buNone/>
              <a:defRPr sz="2835"/>
            </a:lvl5pPr>
            <a:lvl6pPr marL="3240020" indent="0">
              <a:buNone/>
              <a:defRPr sz="2835"/>
            </a:lvl6pPr>
            <a:lvl7pPr marL="3888025" indent="0">
              <a:buNone/>
              <a:defRPr sz="2835"/>
            </a:lvl7pPr>
            <a:lvl8pPr marL="4536030" indent="0">
              <a:buNone/>
              <a:defRPr sz="2835"/>
            </a:lvl8pPr>
            <a:lvl9pPr marL="5184033" indent="0">
              <a:buNone/>
              <a:defRPr sz="2835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92712" y="6587967"/>
            <a:ext cx="4180050" cy="12205023"/>
          </a:xfrm>
        </p:spPr>
        <p:txBody>
          <a:bodyPr/>
          <a:lstStyle>
            <a:lvl1pPr marL="0" indent="0">
              <a:buNone/>
              <a:defRPr sz="2268"/>
            </a:lvl1pPr>
            <a:lvl2pPr marL="648004" indent="0">
              <a:buNone/>
              <a:defRPr sz="1984"/>
            </a:lvl2pPr>
            <a:lvl3pPr marL="1296008" indent="0">
              <a:buNone/>
              <a:defRPr sz="1701"/>
            </a:lvl3pPr>
            <a:lvl4pPr marL="1944013" indent="0">
              <a:buNone/>
              <a:defRPr sz="1418"/>
            </a:lvl4pPr>
            <a:lvl5pPr marL="2592017" indent="0">
              <a:buNone/>
              <a:defRPr sz="1418"/>
            </a:lvl5pPr>
            <a:lvl6pPr marL="3240020" indent="0">
              <a:buNone/>
              <a:defRPr sz="1418"/>
            </a:lvl6pPr>
            <a:lvl7pPr marL="3888025" indent="0">
              <a:buNone/>
              <a:defRPr sz="1418"/>
            </a:lvl7pPr>
            <a:lvl8pPr marL="4536030" indent="0">
              <a:buNone/>
              <a:defRPr sz="1418"/>
            </a:lvl8pPr>
            <a:lvl9pPr marL="5184033" indent="0">
              <a:buNone/>
              <a:defRPr sz="1418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6E1A72-34A7-4777-9297-BECAC6DDF237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29121506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91024" y="1169166"/>
            <a:ext cx="11178302" cy="4244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91024" y="5845805"/>
            <a:ext cx="11178302" cy="1393334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91026" y="20353569"/>
            <a:ext cx="2916079" cy="11691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0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3E6F1D-3C5F-40DC-B246-DD4AB1E6FA63}" type="datetime1">
              <a:rPr lang="ko-KR" altLang="en-US" smtClean="0"/>
              <a:pPr/>
              <a:t>2020-02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293116" y="20353569"/>
            <a:ext cx="4374118" cy="11691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0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153249" y="20353569"/>
            <a:ext cx="2916079" cy="11691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0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CC0877-69F3-4504-A8E9-73C29574224A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xmlns="" val="31109336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hf sldNum="0" hdr="0" ftr="0" dt="0"/>
  <p:txStyles>
    <p:titleStyle>
      <a:lvl1pPr algn="l" defTabSz="1296008" rtl="0" eaLnBrk="1" latinLnBrk="1" hangingPunct="1">
        <a:lnSpc>
          <a:spcPct val="90000"/>
        </a:lnSpc>
        <a:spcBef>
          <a:spcPct val="0"/>
        </a:spcBef>
        <a:buNone/>
        <a:defRPr sz="623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24003" indent="-324003" algn="l" defTabSz="1296008" rtl="0" eaLnBrk="1" latinLnBrk="1" hangingPunct="1">
        <a:lnSpc>
          <a:spcPct val="90000"/>
        </a:lnSpc>
        <a:spcBef>
          <a:spcPts val="1418"/>
        </a:spcBef>
        <a:buFont typeface="Arial" panose="020B0604020202020204" pitchFamily="34" charset="0"/>
        <a:buChar char="•"/>
        <a:defRPr sz="3968" kern="1200">
          <a:solidFill>
            <a:schemeClr val="tx1"/>
          </a:solidFill>
          <a:latin typeface="+mn-lt"/>
          <a:ea typeface="+mn-ea"/>
          <a:cs typeface="+mn-cs"/>
        </a:defRPr>
      </a:lvl1pPr>
      <a:lvl2pPr marL="972007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3402" kern="1200">
          <a:solidFill>
            <a:schemeClr val="tx1"/>
          </a:solidFill>
          <a:latin typeface="+mn-lt"/>
          <a:ea typeface="+mn-ea"/>
          <a:cs typeface="+mn-cs"/>
        </a:defRPr>
      </a:lvl2pPr>
      <a:lvl3pPr marL="1620010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835" kern="1200">
          <a:solidFill>
            <a:schemeClr val="tx1"/>
          </a:solidFill>
          <a:latin typeface="+mn-lt"/>
          <a:ea typeface="+mn-ea"/>
          <a:cs typeface="+mn-cs"/>
        </a:defRPr>
      </a:lvl3pPr>
      <a:lvl4pPr marL="2268014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4pPr>
      <a:lvl5pPr marL="2916020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5pPr>
      <a:lvl6pPr marL="3564023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6pPr>
      <a:lvl7pPr marL="4212027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7pPr>
      <a:lvl8pPr marL="4860032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8pPr>
      <a:lvl9pPr marL="5508036" indent="-324003" algn="l" defTabSz="1296008" rtl="0" eaLnBrk="1" latinLnBrk="1" hangingPunct="1">
        <a:lnSpc>
          <a:spcPct val="90000"/>
        </a:lnSpc>
        <a:spcBef>
          <a:spcPts val="709"/>
        </a:spcBef>
        <a:buFont typeface="Arial" panose="020B0604020202020204" pitchFamily="34" charset="0"/>
        <a:buChar char="•"/>
        <a:defRPr sz="25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1pPr>
      <a:lvl2pPr marL="648004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2pPr>
      <a:lvl3pPr marL="1296008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3pPr>
      <a:lvl4pPr marL="1944013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4pPr>
      <a:lvl5pPr marL="2592017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5pPr>
      <a:lvl6pPr marL="3240020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6pPr>
      <a:lvl7pPr marL="3888025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7pPr>
      <a:lvl8pPr marL="4536030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8pPr>
      <a:lvl9pPr marL="5184033" algn="l" defTabSz="1296008" rtl="0" eaLnBrk="1" latinLnBrk="1" hangingPunct="1">
        <a:defRPr sz="25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표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735549095"/>
              </p:ext>
            </p:extLst>
          </p:nvPr>
        </p:nvGraphicFramePr>
        <p:xfrm>
          <a:off x="81986" y="819529"/>
          <a:ext cx="12834549" cy="11848339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853522">
                  <a:extLst>
                    <a:ext uri="{9D8B030D-6E8A-4147-A177-3AD203B41FA5}">
                      <a16:colId xmlns:a16="http://schemas.microsoft.com/office/drawing/2014/main" xmlns="" val="1409189042"/>
                    </a:ext>
                  </a:extLst>
                </a:gridCol>
                <a:gridCol w="727588">
                  <a:extLst>
                    <a:ext uri="{9D8B030D-6E8A-4147-A177-3AD203B41FA5}">
                      <a16:colId xmlns:a16="http://schemas.microsoft.com/office/drawing/2014/main" xmlns="" val="1870204054"/>
                    </a:ext>
                  </a:extLst>
                </a:gridCol>
                <a:gridCol w="899410">
                  <a:extLst>
                    <a:ext uri="{9D8B030D-6E8A-4147-A177-3AD203B41FA5}">
                      <a16:colId xmlns:a16="http://schemas.microsoft.com/office/drawing/2014/main" xmlns="" val="3037430289"/>
                    </a:ext>
                  </a:extLst>
                </a:gridCol>
                <a:gridCol w="1154243">
                  <a:extLst>
                    <a:ext uri="{9D8B030D-6E8A-4147-A177-3AD203B41FA5}">
                      <a16:colId xmlns:a16="http://schemas.microsoft.com/office/drawing/2014/main" xmlns="" val="4088979873"/>
                    </a:ext>
                  </a:extLst>
                </a:gridCol>
                <a:gridCol w="4473225">
                  <a:extLst>
                    <a:ext uri="{9D8B030D-6E8A-4147-A177-3AD203B41FA5}">
                      <a16:colId xmlns:a16="http://schemas.microsoft.com/office/drawing/2014/main" xmlns="" val="120783647"/>
                    </a:ext>
                  </a:extLst>
                </a:gridCol>
                <a:gridCol w="957943">
                  <a:extLst>
                    <a:ext uri="{9D8B030D-6E8A-4147-A177-3AD203B41FA5}">
                      <a16:colId xmlns:a16="http://schemas.microsoft.com/office/drawing/2014/main" xmlns="" val="3270725404"/>
                    </a:ext>
                  </a:extLst>
                </a:gridCol>
                <a:gridCol w="1088571">
                  <a:extLst>
                    <a:ext uri="{9D8B030D-6E8A-4147-A177-3AD203B41FA5}">
                      <a16:colId xmlns:a16="http://schemas.microsoft.com/office/drawing/2014/main" xmlns="" val="3683565691"/>
                    </a:ext>
                  </a:extLst>
                </a:gridCol>
                <a:gridCol w="773462">
                  <a:extLst>
                    <a:ext uri="{9D8B030D-6E8A-4147-A177-3AD203B41FA5}">
                      <a16:colId xmlns:a16="http://schemas.microsoft.com/office/drawing/2014/main" xmlns="" val="3525253308"/>
                    </a:ext>
                  </a:extLst>
                </a:gridCol>
                <a:gridCol w="906585">
                  <a:extLst>
                    <a:ext uri="{9D8B030D-6E8A-4147-A177-3AD203B41FA5}">
                      <a16:colId xmlns:a16="http://schemas.microsoft.com/office/drawing/2014/main" xmlns="" val="2749235395"/>
                    </a:ext>
                  </a:extLst>
                </a:gridCol>
              </a:tblGrid>
              <a:tr h="404646">
                <a:tc rowSpan="2" gridSpan="2">
                  <a:txBody>
                    <a:bodyPr/>
                    <a:lstStyle/>
                    <a:p>
                      <a:pPr algn="l" latinLnBrk="1">
                        <a:lnSpc>
                          <a:spcPct val="80000"/>
                        </a:lnSpc>
                      </a:pPr>
                      <a:r>
                        <a:rPr lang="en-US" altLang="ko-KR" sz="20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.      </a:t>
                      </a: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udy 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 hMerge="1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FS/ME</a:t>
                      </a:r>
                      <a:r>
                        <a:rPr lang="en-US" altLang="ko-KR" sz="1500" baseline="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ases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es of</a:t>
                      </a:r>
                      <a:r>
                        <a:rPr lang="en-US" altLang="ko-KR" sz="1500" baseline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ommunity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idence Rate (%)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te (%) 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%-CI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ight %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506282246"/>
                  </a:ext>
                </a:extLst>
              </a:tr>
              <a:tr h="404646">
                <a:tc gridSpan="2"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xed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ndom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26826388"/>
                  </a:ext>
                </a:extLst>
              </a:tr>
              <a:tr h="292918">
                <a:tc gridSpan="2">
                  <a:txBody>
                    <a:bodyPr/>
                    <a:lstStyle/>
                    <a:p>
                      <a:pPr algn="l" latinLnBrk="0">
                        <a:lnSpc>
                          <a:spcPct val="80000"/>
                        </a:lnSpc>
                        <a:spcAft>
                          <a:spcPts val="0"/>
                        </a:spcAft>
                      </a:pPr>
                      <a:r>
                        <a:rPr lang="en-US" sz="15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Shi et al., </a:t>
                      </a:r>
                      <a:r>
                        <a:rPr lang="en-US" sz="15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018 [32]</a:t>
                      </a:r>
                      <a:endParaRPr lang="ko-KR" sz="15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139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35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9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77; 1.05]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102593090"/>
                  </a:ext>
                </a:extLst>
              </a:tr>
              <a:tr h="292918">
                <a:tc gridSpan="2">
                  <a:txBody>
                    <a:bodyPr/>
                    <a:lstStyle/>
                    <a:p>
                      <a:pPr algn="l" latinLnBrk="0">
                        <a:lnSpc>
                          <a:spcPct val="80000"/>
                        </a:lnSpc>
                        <a:spcAft>
                          <a:spcPts val="0"/>
                        </a:spcAft>
                      </a:pPr>
                      <a:r>
                        <a:rPr lang="en-US" sz="15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Collin et al., </a:t>
                      </a:r>
                      <a:r>
                        <a:rPr lang="en-US" sz="15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016 [38]</a:t>
                      </a:r>
                      <a:endParaRPr lang="ko-KR" sz="15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396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86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1.61;</a:t>
                      </a:r>
                      <a:r>
                        <a:rPr lang="en-US" altLang="ko-KR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2.14]</a:t>
                      </a: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6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898440909"/>
                  </a:ext>
                </a:extLst>
              </a:tr>
              <a:tr h="292918">
                <a:tc gridSpan="2">
                  <a:txBody>
                    <a:bodyPr/>
                    <a:lstStyle/>
                    <a:p>
                      <a:pPr algn="l" latinLnBrk="0">
                        <a:lnSpc>
                          <a:spcPct val="80000"/>
                        </a:lnSpc>
                        <a:spcAft>
                          <a:spcPts val="0"/>
                        </a:spcAft>
                      </a:pPr>
                      <a:r>
                        <a:rPr lang="en-US" sz="15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Rusu et al., </a:t>
                      </a:r>
                      <a:r>
                        <a:rPr lang="en-US" sz="15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015 [63]</a:t>
                      </a:r>
                      <a:endParaRPr lang="ko-KR" sz="15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6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9101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7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1.60; 1.81] 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1.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541605016"/>
                  </a:ext>
                </a:extLst>
              </a:tr>
              <a:tr h="304454">
                <a:tc gridSpan="2">
                  <a:txBody>
                    <a:bodyPr/>
                    <a:lstStyle/>
                    <a:p>
                      <a:pPr algn="l" latinLnBrk="0">
                        <a:lnSpc>
                          <a:spcPct val="80000"/>
                        </a:lnSpc>
                        <a:spcAft>
                          <a:spcPts val="0"/>
                        </a:spcAft>
                      </a:pPr>
                      <a:r>
                        <a:rPr lang="en-US" sz="15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Vincent et al., </a:t>
                      </a:r>
                      <a:r>
                        <a:rPr lang="en-US" sz="15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012 [64]</a:t>
                      </a:r>
                      <a:endParaRPr lang="ko-KR" sz="15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6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3841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03; 0.05]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7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938537908"/>
                  </a:ext>
                </a:extLst>
              </a:tr>
              <a:tr h="288432">
                <a:tc gridSpan="2">
                  <a:txBody>
                    <a:bodyPr/>
                    <a:lstStyle/>
                    <a:p>
                      <a:pPr algn="l" latinLnBrk="0">
                        <a:lnSpc>
                          <a:spcPct val="80000"/>
                        </a:lnSpc>
                        <a:spcAft>
                          <a:spcPts val="0"/>
                        </a:spcAft>
                      </a:pPr>
                      <a:r>
                        <a:rPr lang="en-US" sz="15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Bhui et al., </a:t>
                      </a:r>
                      <a:r>
                        <a:rPr lang="en-US" sz="15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</a:rPr>
                        <a:t>2011 [65]</a:t>
                      </a:r>
                      <a:endParaRPr lang="ko-KR" sz="1500" kern="100" dirty="0">
                        <a:effectLst/>
                        <a:latin typeface="맑은 고딕" panose="020B0503020000020004" pitchFamily="50" charset="-127"/>
                        <a:ea typeface="맑은 고딕" panose="020B0503020000020004" pitchFamily="50" charset="-127"/>
                      </a:endParaRPr>
                    </a:p>
                  </a:txBody>
                  <a:tcPr marL="62865" marR="6286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8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81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5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2.09; 3.05] 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850794679"/>
                  </a:ext>
                </a:extLst>
              </a:tr>
              <a:tr h="288432">
                <a:tc gridSpan="2">
                  <a:txBody>
                    <a:bodyPr/>
                    <a:lstStyle/>
                    <a:p>
                      <a:pPr algn="l" latinLnBrk="0">
                        <a:lnSpc>
                          <a:spcPct val="80000"/>
                        </a:lnSpc>
                        <a:spcAft>
                          <a:spcPts val="0"/>
                        </a:spcAft>
                      </a:pPr>
                      <a:r>
                        <a:rPr lang="en-US" sz="1500" kern="0" dirty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amaguchi et al., </a:t>
                      </a:r>
                      <a:r>
                        <a:rPr lang="en-US" sz="1500" kern="0" dirty="0" smtClean="0"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1 [66]</a:t>
                      </a:r>
                      <a:endParaRPr lang="ko-KR" sz="1500" kern="100" dirty="0"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3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98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58; 1.65]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562126362"/>
                  </a:ext>
                </a:extLst>
              </a:tr>
              <a:tr h="288432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altLang="ko-KR" sz="1500" kern="1200" dirty="0" smtClean="0">
                          <a:solidFill>
                            <a:schemeClr val="dk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van't Leven et al., 2010 [68]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9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062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98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80; 1.21]  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052930925"/>
                  </a:ext>
                </a:extLst>
              </a:tr>
              <a:tr h="288432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Kim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,</a:t>
                      </a:r>
                      <a:r>
                        <a:rPr lang="en-US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8 [70]   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44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6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01; 0.43]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6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943389006"/>
                  </a:ext>
                </a:extLst>
              </a:tr>
              <a:tr h="288432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Kim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H,</a:t>
                      </a:r>
                      <a:r>
                        <a:rPr lang="en-US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8 [71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1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4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15; 1.10]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7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78963373"/>
                  </a:ext>
                </a:extLst>
              </a:tr>
              <a:tr h="288432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eeves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7 [72]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62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0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1.67; 2.42]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5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252899567"/>
                  </a:ext>
                </a:extLst>
              </a:tr>
              <a:tr h="304454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Njoku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7 [50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87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28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09; 0.86]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937242282"/>
                  </a:ext>
                </a:extLst>
              </a:tr>
              <a:tr h="288432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imes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7 [74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42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48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18; 1.27]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7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029290213"/>
                  </a:ext>
                </a:extLst>
              </a:tr>
              <a:tr h="288432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Furberg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5 [75]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6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591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7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2.30; 3.27]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7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003153161"/>
                  </a:ext>
                </a:extLst>
              </a:tr>
              <a:tr h="304454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Evangard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5 [76]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32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405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3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2.17; 2.51]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6.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746927803"/>
                  </a:ext>
                </a:extLst>
              </a:tr>
              <a:tr h="304454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Yiu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5 [77]   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5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1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.4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5.03;</a:t>
                      </a:r>
                      <a:r>
                        <a:rPr lang="en-US" altLang="ko-KR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.18]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877213210"/>
                  </a:ext>
                </a:extLst>
              </a:tr>
              <a:tr h="288432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uibers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4 [78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9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99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6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3.15; 4.16]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7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83606399"/>
                  </a:ext>
                </a:extLst>
              </a:tr>
              <a:tr h="288432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Jones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4 [79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586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3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23; 0.49]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114836199"/>
                  </a:ext>
                </a:extLst>
              </a:tr>
              <a:tr h="288432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Farmer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4 [80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68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38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1.71; 3.32]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7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607206588"/>
                  </a:ext>
                </a:extLst>
              </a:tr>
              <a:tr h="288432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halder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3 [81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4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09; 0.38]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8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991075489"/>
                  </a:ext>
                </a:extLst>
              </a:tr>
              <a:tr h="288432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eyes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3 [54]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162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6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45; 0.81]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610182719"/>
                  </a:ext>
                </a:extLst>
              </a:tr>
              <a:tr h="288432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cCauley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2 [82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99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b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25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1.42; 3.58]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8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023522958"/>
                  </a:ext>
                </a:extLst>
              </a:tr>
              <a:tr h="320020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Lindal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2 [34] 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2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2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7.6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6.61; 8.78]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810402986"/>
                  </a:ext>
                </a:extLst>
              </a:tr>
              <a:tr h="304454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Lindal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2 [34]  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4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2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1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1.64;</a:t>
                      </a:r>
                      <a:r>
                        <a:rPr lang="en-US" altLang="ko-KR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80]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788226694"/>
                  </a:ext>
                </a:extLst>
              </a:tr>
              <a:tr h="288432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Lindal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2 [34]  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2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00; 0.32]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785630432"/>
                  </a:ext>
                </a:extLst>
              </a:tr>
              <a:tr h="288432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Lindal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2 [34] 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4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2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7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3.05;</a:t>
                      </a:r>
                      <a:r>
                        <a:rPr lang="en-US" altLang="ko-KR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4.57]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424452647"/>
                  </a:ext>
                </a:extLst>
              </a:tr>
              <a:tr h="320020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Jason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9 [53]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9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67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4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35; 0.50]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6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674072927"/>
                  </a:ext>
                </a:extLst>
              </a:tr>
              <a:tr h="320020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Steele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8 [87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627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2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16; 0.32]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7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071657"/>
                  </a:ext>
                </a:extLst>
              </a:tr>
              <a:tr h="304454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Fukuda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7 [88]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8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89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4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2.65; 4.44]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40685595"/>
                  </a:ext>
                </a:extLst>
              </a:tr>
              <a:tr h="304454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Lawrie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nd</a:t>
                      </a:r>
                      <a:r>
                        <a:rPr lang="en-US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Pelosi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5 [60]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95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8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22; 1.53]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035610692"/>
                  </a:ext>
                </a:extLst>
              </a:tr>
              <a:tr h="288432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Buchwald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nd</a:t>
                      </a:r>
                      <a:r>
                        <a:rPr lang="en-US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Umali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5 [91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66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03; 0.30]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956945739"/>
                  </a:ext>
                </a:extLst>
              </a:tr>
              <a:tr h="288432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Jason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5 [92]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1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2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05; 0.88] 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125116865"/>
                  </a:ext>
                </a:extLst>
              </a:tr>
              <a:tr h="288432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rice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2 [33]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538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00; 0.05]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6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601623896"/>
                  </a:ext>
                </a:extLst>
              </a:tr>
              <a:tr h="320020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Lloyd 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0 [25]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2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400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03; 0.05]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85417558"/>
                  </a:ext>
                </a:extLst>
              </a:tr>
              <a:tr h="361550">
                <a:tc gridSpan="2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r>
                        <a:rPr lang="en-US" altLang="ko-KR" sz="15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xed effect model </a:t>
                      </a:r>
                      <a:endParaRPr lang="ko-KR" altLang="en-US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40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sz="10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2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1.67; 1.78]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.0%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014201241"/>
                  </a:ext>
                </a:extLst>
              </a:tr>
              <a:tr h="365760">
                <a:tc gridSpan="3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r>
                        <a:rPr lang="en-US" altLang="ko-KR" sz="15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ndom</a:t>
                      </a:r>
                      <a:r>
                        <a:rPr lang="en-US" altLang="ko-KR" sz="1500" b="1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effects model</a:t>
                      </a:r>
                      <a:endParaRPr lang="ko-KR" altLang="en-US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4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/>
                      <a:endParaRPr lang="ko-KR" altLang="en-US" sz="10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0.76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0.53; 1.10]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.0%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161385903"/>
                  </a:ext>
                </a:extLst>
              </a:tr>
              <a:tr h="541517"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r>
                        <a:rPr lang="en-US" altLang="ko-KR" sz="15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terogeneity </a:t>
                      </a:r>
                      <a:endParaRPr lang="ko-KR" altLang="en-US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4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latinLnBrk="1">
                        <a:lnSpc>
                          <a:spcPct val="80000"/>
                        </a:lnSpc>
                      </a:pPr>
                      <a:r>
                        <a:rPr lang="en-US" altLang="ko-KR" sz="1500" i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US" altLang="ko-KR" sz="1500" baseline="300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= 99.0%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i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</a:t>
                      </a:r>
                      <a:r>
                        <a:rPr lang="en-US" altLang="ko-KR" sz="1500" baseline="300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= </a:t>
                      </a: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0363</a:t>
                      </a:r>
                    </a:p>
                    <a:p>
                      <a:pPr algn="l" latinLnBrk="1">
                        <a:lnSpc>
                          <a:spcPct val="80000"/>
                        </a:lnSpc>
                      </a:pPr>
                      <a:r>
                        <a:rPr lang="en-US" altLang="ko-KR" sz="1500" i="1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 P</a:t>
                      </a: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</a:t>
                      </a:r>
                      <a:r>
                        <a:rPr lang="en-US" altLang="ko-KR" sz="1500" baseline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0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838004142"/>
                  </a:ext>
                </a:extLst>
              </a:tr>
            </a:tbl>
          </a:graphicData>
        </a:graphic>
      </p:graphicFrame>
      <p:graphicFrame>
        <p:nvGraphicFramePr>
          <p:cNvPr id="10" name="표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3883939588"/>
              </p:ext>
            </p:extLst>
          </p:nvPr>
        </p:nvGraphicFramePr>
        <p:xfrm>
          <a:off x="81984" y="12534665"/>
          <a:ext cx="12834550" cy="894536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853522">
                  <a:extLst>
                    <a:ext uri="{9D8B030D-6E8A-4147-A177-3AD203B41FA5}">
                      <a16:colId xmlns:a16="http://schemas.microsoft.com/office/drawing/2014/main" xmlns="" val="1409189042"/>
                    </a:ext>
                  </a:extLst>
                </a:gridCol>
                <a:gridCol w="562699">
                  <a:extLst>
                    <a:ext uri="{9D8B030D-6E8A-4147-A177-3AD203B41FA5}">
                      <a16:colId xmlns:a16="http://schemas.microsoft.com/office/drawing/2014/main" xmlns="" val="1870204054"/>
                    </a:ext>
                  </a:extLst>
                </a:gridCol>
                <a:gridCol w="854439">
                  <a:extLst>
                    <a:ext uri="{9D8B030D-6E8A-4147-A177-3AD203B41FA5}">
                      <a16:colId xmlns:a16="http://schemas.microsoft.com/office/drawing/2014/main" xmlns="" val="33497229"/>
                    </a:ext>
                  </a:extLst>
                </a:gridCol>
                <a:gridCol w="1169233">
                  <a:extLst>
                    <a:ext uri="{9D8B030D-6E8A-4147-A177-3AD203B41FA5}">
                      <a16:colId xmlns:a16="http://schemas.microsoft.com/office/drawing/2014/main" xmlns="" val="4088979873"/>
                    </a:ext>
                  </a:extLst>
                </a:gridCol>
                <a:gridCol w="4472155">
                  <a:extLst>
                    <a:ext uri="{9D8B030D-6E8A-4147-A177-3AD203B41FA5}">
                      <a16:colId xmlns:a16="http://schemas.microsoft.com/office/drawing/2014/main" xmlns="" val="120783647"/>
                    </a:ext>
                  </a:extLst>
                </a:gridCol>
                <a:gridCol w="898359">
                  <a:extLst>
                    <a:ext uri="{9D8B030D-6E8A-4147-A177-3AD203B41FA5}">
                      <a16:colId xmlns:a16="http://schemas.microsoft.com/office/drawing/2014/main" xmlns="" val="3270725404"/>
                    </a:ext>
                  </a:extLst>
                </a:gridCol>
                <a:gridCol w="1267327">
                  <a:extLst>
                    <a:ext uri="{9D8B030D-6E8A-4147-A177-3AD203B41FA5}">
                      <a16:colId xmlns:a16="http://schemas.microsoft.com/office/drawing/2014/main" xmlns="" val="3683565691"/>
                    </a:ext>
                  </a:extLst>
                </a:gridCol>
                <a:gridCol w="850231">
                  <a:extLst>
                    <a:ext uri="{9D8B030D-6E8A-4147-A177-3AD203B41FA5}">
                      <a16:colId xmlns:a16="http://schemas.microsoft.com/office/drawing/2014/main" xmlns="" val="3525253308"/>
                    </a:ext>
                  </a:extLst>
                </a:gridCol>
                <a:gridCol w="906585">
                  <a:extLst>
                    <a:ext uri="{9D8B030D-6E8A-4147-A177-3AD203B41FA5}">
                      <a16:colId xmlns:a16="http://schemas.microsoft.com/office/drawing/2014/main" xmlns="" val="2749235395"/>
                    </a:ext>
                  </a:extLst>
                </a:gridCol>
              </a:tblGrid>
              <a:tr h="404646">
                <a:tc rowSpan="2" gridSpan="2">
                  <a:txBody>
                    <a:bodyPr/>
                    <a:lstStyle/>
                    <a:p>
                      <a:pPr algn="l" latinLnBrk="1">
                        <a:lnSpc>
                          <a:spcPct val="80000"/>
                        </a:lnSpc>
                      </a:pPr>
                      <a:r>
                        <a:rPr lang="en-US" altLang="ko-KR" sz="20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.      </a:t>
                      </a: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tudy 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 hMerge="1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FS/ME</a:t>
                      </a:r>
                      <a:r>
                        <a:rPr lang="en-US" altLang="ko-KR" sz="1500" baseline="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ases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ses of</a:t>
                      </a:r>
                      <a:r>
                        <a:rPr lang="en-US" altLang="ko-KR" sz="1500" baseline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Primary care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idence Rate (%)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te (%) 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1" hangingPunct="1">
                        <a:lnSpc>
                          <a:spcPct val="8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5%-CI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eight %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3" marR="68583" marT="34292" marB="3429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506282246"/>
                  </a:ext>
                </a:extLst>
              </a:tr>
              <a:tr h="404646">
                <a:tc gridSpan="2"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xed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80000"/>
                        </a:lnSpc>
                      </a:pP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ndom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ysDash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237727645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Nacul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1 [37]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7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315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rowSpan="25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17; 0.21] 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489442889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Nacul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1 [37] 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6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315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09; 0.12] 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653068010"/>
                  </a:ext>
                </a:extLst>
              </a:tr>
              <a:tr h="296561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Nacul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1 [37]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315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0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02; 0.04]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464951139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Nijhof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11 [67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1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3636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09; 0.14]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5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180887130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ho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9 [69] 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1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59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07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1.58;</a:t>
                      </a:r>
                      <a:r>
                        <a:rPr lang="en-US" altLang="ko-KR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73]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78994920"/>
                  </a:ext>
                </a:extLst>
              </a:tr>
              <a:tr h="313038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ho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9 [69] 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14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6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1.26; 2.06]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13812699"/>
                  </a:ext>
                </a:extLst>
              </a:tr>
              <a:tr h="313038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aralikar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7 [73]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4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74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5.0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4.10; 6.14] 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540650023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Kim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H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5 [55]   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48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6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33;</a:t>
                      </a:r>
                      <a:r>
                        <a:rPr lang="en-US" altLang="ko-KR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13] 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38437475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Kim CH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0 [83] 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88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2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69; 2.14]  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83586543"/>
                  </a:ext>
                </a:extLst>
              </a:tr>
              <a:tr h="296561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Ji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JD,</a:t>
                      </a:r>
                      <a:r>
                        <a:rPr lang="en-US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00 [84]  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1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26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0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1.43; 2.89]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7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783425823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Ji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JD,</a:t>
                      </a:r>
                      <a:r>
                        <a:rPr lang="en-US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9 [85] 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3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8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1.02; 3.51]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358115011"/>
                  </a:ext>
                </a:extLst>
              </a:tr>
              <a:tr h="296561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Jason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8 [86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7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40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79; 1.50]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7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9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848131884"/>
                  </a:ext>
                </a:extLst>
              </a:tr>
              <a:tr h="32951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Wessely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7 [16]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8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85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4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97; 2.04]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6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650182046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Wessely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7 [16]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2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85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6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2.00; 3.44] 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136350838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Wessely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7 [16]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85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2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81;</a:t>
                      </a:r>
                      <a:r>
                        <a:rPr lang="en-US" altLang="ko-KR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80]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163953607"/>
                  </a:ext>
                </a:extLst>
              </a:tr>
              <a:tr h="313038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Wessely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7 [16]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4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85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2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1.65; 2.98] 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682801446"/>
                  </a:ext>
                </a:extLst>
              </a:tr>
              <a:tr h="313038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Versluis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7 [89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300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07; 0.16]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5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63540836"/>
                  </a:ext>
                </a:extLst>
              </a:tr>
              <a:tr h="313038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Minowa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nd</a:t>
                      </a:r>
                      <a:r>
                        <a:rPr lang="en-US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Jiamo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6 [90]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9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550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6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54; 0.66]  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.6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862505575"/>
                  </a:ext>
                </a:extLst>
              </a:tr>
              <a:tr h="296561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Jason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3 [93]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74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75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41; 1.35]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8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461192299"/>
                  </a:ext>
                </a:extLst>
              </a:tr>
              <a:tr h="296563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Bates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3 [39]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95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endParaRPr lang="en-US" altLang="ko-KR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54;1.87]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2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343831562"/>
                  </a:ext>
                </a:extLst>
              </a:tr>
              <a:tr h="313038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Bates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3 [39]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95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3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10; 0.93]  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435511827"/>
                  </a:ext>
                </a:extLst>
              </a:tr>
              <a:tr h="280087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Bates </a:t>
                      </a:r>
                      <a:r>
                        <a:rPr lang="en-US" altLang="ko-KR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et</a:t>
                      </a:r>
                      <a:r>
                        <a:rPr lang="en-US" altLang="ko-KR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al.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3 [39]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95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40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15;</a:t>
                      </a:r>
                      <a:r>
                        <a:rPr lang="en-US" altLang="ko-KR" sz="15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.07]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1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290518874"/>
                  </a:ext>
                </a:extLst>
              </a:tr>
              <a:tr h="280087">
                <a:tc gridSpan="2">
                  <a:txBody>
                    <a:bodyPr/>
                    <a:lstStyle/>
                    <a:p>
                      <a:pPr algn="l" fontAlgn="ctr">
                        <a:lnSpc>
                          <a:spcPct val="20000"/>
                        </a:lnSpc>
                      </a:pPr>
                      <a:r>
                        <a:rPr lang="en-US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Ho-yen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nd</a:t>
                      </a:r>
                      <a:r>
                        <a:rPr lang="en-US" sz="1500" b="0" i="0" u="none" strike="noStrike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 Mc, </a:t>
                      </a:r>
                      <a:r>
                        <a:rPr lang="en-US" sz="15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991 [36]   </a:t>
                      </a:r>
                      <a:endParaRPr lang="en-US" sz="15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4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9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8993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0.13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[0.12; 0.15]    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6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lnSpc>
                          <a:spcPct val="20000"/>
                        </a:lnSpc>
                      </a:pPr>
                      <a:r>
                        <a:rPr lang="en-US" altLang="ko-KR" sz="15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4</a:t>
                      </a:r>
                    </a:p>
                  </a:txBody>
                  <a:tcPr marL="12700" marR="12700" marT="1270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145126928"/>
                  </a:ext>
                </a:extLst>
              </a:tr>
              <a:tr h="369205">
                <a:tc gridSpan="3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r>
                        <a:rPr lang="en-US" altLang="ko-KR" sz="15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</a:p>
                    <a:p>
                      <a:pPr latinLnBrk="1">
                        <a:lnSpc>
                          <a:spcPct val="20000"/>
                        </a:lnSpc>
                      </a:pPr>
                      <a:r>
                        <a:rPr lang="en-US" altLang="ko-KR" sz="15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ixed effect model </a:t>
                      </a:r>
                      <a:endParaRPr lang="ko-KR" altLang="en-US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40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9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0.37; 0.41]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.0%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014201241"/>
                  </a:ext>
                </a:extLst>
              </a:tr>
              <a:tr h="290295">
                <a:tc gridSpan="3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endParaRPr lang="en-US" altLang="ko-KR" sz="1500" b="1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20000"/>
                        </a:lnSpc>
                      </a:pPr>
                      <a:r>
                        <a:rPr lang="en-US" altLang="ko-KR" sz="1500" b="1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ndom</a:t>
                      </a:r>
                      <a:r>
                        <a:rPr lang="en-US" altLang="ko-KR" sz="1500" b="1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b="1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ffects model</a:t>
                      </a:r>
                      <a:endParaRPr lang="ko-KR" altLang="en-US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4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pPr latinLnBrk="1">
                        <a:lnSpc>
                          <a:spcPct val="20000"/>
                        </a:lnSpc>
                      </a:pPr>
                      <a:endParaRPr lang="ko-KR" altLang="en-US" sz="11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0.63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0.37; 1.10]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-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20000"/>
                        </a:lnSpc>
                      </a:pPr>
                      <a:r>
                        <a:rPr lang="en-US" altLang="ko-KR" sz="15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.0%</a:t>
                      </a: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257745429"/>
                  </a:ext>
                </a:extLst>
              </a:tr>
              <a:tr h="556781"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r>
                        <a:rPr lang="en-US" altLang="ko-KR" sz="15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eterogeneity </a:t>
                      </a:r>
                      <a:endParaRPr lang="ko-KR" altLang="en-US" sz="1500" b="1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400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gridSpan="2">
                  <a:txBody>
                    <a:bodyPr/>
                    <a:lstStyle/>
                    <a:p>
                      <a:pPr algn="l" latinLnBrk="1">
                        <a:lnSpc>
                          <a:spcPct val="100000"/>
                        </a:lnSpc>
                      </a:pPr>
                      <a:r>
                        <a:rPr lang="en-US" altLang="ko-KR" sz="1500" i="1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</a:t>
                      </a:r>
                      <a:r>
                        <a:rPr lang="en-US" altLang="ko-KR" sz="1500" baseline="300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= 99.4%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latinLnBrk="1">
                        <a:lnSpc>
                          <a:spcPct val="100000"/>
                        </a:lnSpc>
                      </a:pPr>
                      <a:r>
                        <a:rPr lang="en-US" altLang="ko-KR" sz="1500" i="1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t</a:t>
                      </a:r>
                      <a:r>
                        <a:rPr lang="en-US" altLang="ko-KR" sz="1500" baseline="300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 1.7199</a:t>
                      </a:r>
                    </a:p>
                    <a:p>
                      <a:pPr marL="0" marR="0" lvl="0" indent="0" algn="l" defTabSz="1320759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1500" i="1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 P</a:t>
                      </a:r>
                      <a:r>
                        <a:rPr lang="en-US" altLang="ko-KR" sz="1500" dirty="0" smtClean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150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=</a:t>
                      </a:r>
                      <a:r>
                        <a:rPr lang="en-US" altLang="ko-KR" sz="1500" baseline="0" dirty="0">
                          <a:solidFill>
                            <a:schemeClr val="tx1">
                              <a:lumMod val="75000"/>
                              <a:lumOff val="25000"/>
                            </a:schemeClr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0</a:t>
                      </a:r>
                      <a:endParaRPr lang="ko-KR" altLang="en-US" sz="1500" dirty="0">
                        <a:solidFill>
                          <a:schemeClr val="tx1">
                            <a:lumMod val="75000"/>
                            <a:lumOff val="25000"/>
                          </a:schemeClr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68583" marR="68583" marT="34292" marB="34292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en-US" altLang="ko-KR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latinLnBrk="1">
                        <a:lnSpc>
                          <a:spcPct val="10000"/>
                        </a:lnSpc>
                      </a:pPr>
                      <a:endParaRPr lang="ko-KR" altLang="en-US" sz="15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838004142"/>
                  </a:ext>
                </a:extLst>
              </a:tr>
            </a:tbl>
          </a:graphicData>
        </a:graphic>
      </p:graphicFrame>
      <p:grpSp>
        <p:nvGrpSpPr>
          <p:cNvPr id="11" name="그룹 10"/>
          <p:cNvGrpSpPr/>
          <p:nvPr/>
        </p:nvGrpSpPr>
        <p:grpSpPr>
          <a:xfrm>
            <a:off x="4499399" y="1525930"/>
            <a:ext cx="5053335" cy="10996637"/>
            <a:chOff x="4517121" y="1708810"/>
            <a:chExt cx="5053335" cy="10996637"/>
          </a:xfrm>
        </p:grpSpPr>
        <p:pic>
          <p:nvPicPr>
            <p:cNvPr id="12" name="그림 11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4545932" y="1708810"/>
              <a:ext cx="4720964" cy="10393028"/>
            </a:xfrm>
            <a:prstGeom prst="rect">
              <a:avLst/>
            </a:prstGeom>
          </p:spPr>
        </p:pic>
        <p:grpSp>
          <p:nvGrpSpPr>
            <p:cNvPr id="13" name="그룹 12"/>
            <p:cNvGrpSpPr/>
            <p:nvPr/>
          </p:nvGrpSpPr>
          <p:grpSpPr>
            <a:xfrm>
              <a:off x="4517121" y="12328745"/>
              <a:ext cx="5053335" cy="376702"/>
              <a:chOff x="4100562" y="12230269"/>
              <a:chExt cx="5740399" cy="376702"/>
            </a:xfrm>
          </p:grpSpPr>
          <p:pic>
            <p:nvPicPr>
              <p:cNvPr id="14" name="그림 13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tretch>
                <a:fillRect/>
              </a:stretch>
            </p:blipFill>
            <p:spPr>
              <a:xfrm>
                <a:off x="4195642" y="12230269"/>
                <a:ext cx="4877198" cy="96533"/>
              </a:xfrm>
              <a:prstGeom prst="rect">
                <a:avLst/>
              </a:prstGeom>
            </p:spPr>
          </p:pic>
          <p:sp>
            <p:nvSpPr>
              <p:cNvPr id="15" name="TextBox 14"/>
              <p:cNvSpPr txBox="1"/>
              <p:nvPr/>
            </p:nvSpPr>
            <p:spPr>
              <a:xfrm>
                <a:off x="4100562" y="12288422"/>
                <a:ext cx="5740399" cy="3185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7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0.0    1.0     2.0     3.0     4.0     5.0    6.0     7.0     8.0    9.0 (%) </a:t>
                </a:r>
                <a:endParaRPr lang="ko-KR" altLang="en-US" sz="147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16" name="그룹 15"/>
          <p:cNvGrpSpPr/>
          <p:nvPr/>
        </p:nvGrpSpPr>
        <p:grpSpPr>
          <a:xfrm>
            <a:off x="4433331" y="13200395"/>
            <a:ext cx="5499996" cy="8262699"/>
            <a:chOff x="4168293" y="13383275"/>
            <a:chExt cx="5723467" cy="8262699"/>
          </a:xfrm>
        </p:grpSpPr>
        <p:pic>
          <p:nvPicPr>
            <p:cNvPr id="17" name="그림 16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tretch>
              <a:fillRect/>
            </a:stretch>
          </p:blipFill>
          <p:spPr>
            <a:xfrm>
              <a:off x="4237030" y="13383275"/>
              <a:ext cx="4966914" cy="7667602"/>
            </a:xfrm>
            <a:prstGeom prst="rect">
              <a:avLst/>
            </a:prstGeom>
          </p:spPr>
        </p:pic>
        <p:grpSp>
          <p:nvGrpSpPr>
            <p:cNvPr id="18" name="그룹 17"/>
            <p:cNvGrpSpPr/>
            <p:nvPr/>
          </p:nvGrpSpPr>
          <p:grpSpPr>
            <a:xfrm>
              <a:off x="4168293" y="21204722"/>
              <a:ext cx="5723467" cy="441252"/>
              <a:chOff x="4168293" y="21204722"/>
              <a:chExt cx="5723467" cy="441252"/>
            </a:xfrm>
          </p:grpSpPr>
          <p:pic>
            <p:nvPicPr>
              <p:cNvPr id="19" name="그림 18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tretch>
                <a:fillRect/>
              </a:stretch>
            </p:blipFill>
            <p:spPr>
              <a:xfrm>
                <a:off x="4384660" y="21204722"/>
                <a:ext cx="5045124" cy="203700"/>
              </a:xfrm>
              <a:prstGeom prst="rect">
                <a:avLst/>
              </a:prstGeom>
            </p:spPr>
          </p:pic>
          <p:sp>
            <p:nvSpPr>
              <p:cNvPr id="20" name="TextBox 19"/>
              <p:cNvSpPr txBox="1"/>
              <p:nvPr/>
            </p:nvSpPr>
            <p:spPr>
              <a:xfrm>
                <a:off x="4168293" y="21327425"/>
                <a:ext cx="5723467" cy="31854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47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0.0            1.0            2.0            3.0            4.0            5.0             6.0 (%) </a:t>
                </a:r>
                <a:endParaRPr lang="ko-KR" altLang="en-US" sz="147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21" name="TextBox 20">
            <a:extLst>
              <a:ext uri="{FF2B5EF4-FFF2-40B4-BE49-F238E27FC236}">
                <a16:creationId xmlns:a16="http://schemas.microsoft.com/office/drawing/2014/main" xmlns="" id="{E6ABCF5D-6227-477D-A84F-866680B7F045}"/>
              </a:ext>
            </a:extLst>
          </p:cNvPr>
          <p:cNvSpPr txBox="1"/>
          <p:nvPr/>
        </p:nvSpPr>
        <p:spPr>
          <a:xfrm>
            <a:off x="38084" y="525135"/>
            <a:ext cx="111654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atinLnBrk="1"/>
            <a:r>
              <a:rPr lang="en-US" altLang="ko-KR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2 </a:t>
            </a:r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ta-analysis of CFS/ME prevalence in community (A) and primary care (B) </a:t>
            </a:r>
            <a:r>
              <a:rPr lang="en-US" altLang="ko-KR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ttings</a:t>
            </a:r>
            <a:endParaRPr lang="ko-KR" altLang="ko-KR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596393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70</TotalTime>
  <Words>1162</Words>
  <Application>Microsoft Office PowerPoint</Application>
  <PresentationFormat>Custom</PresentationFormat>
  <Paragraphs>71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테마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0016236</cp:lastModifiedBy>
  <cp:revision>21</cp:revision>
  <cp:lastPrinted>2020-01-02T00:55:33Z</cp:lastPrinted>
  <dcterms:created xsi:type="dcterms:W3CDTF">2019-12-30T09:07:39Z</dcterms:created>
  <dcterms:modified xsi:type="dcterms:W3CDTF">2020-02-15T03:25:07Z</dcterms:modified>
</cp:coreProperties>
</file>